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7315200" cy="96012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B30F216-BA47-469A-B3C0-B57F4189621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BEEFD0F-FBED-4F65-AE77-23969B3E133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7E55210-FE35-4F8B-BCEF-163606FDB82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C0DA378-A8AF-4807-9EA4-D1A650A1222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AD9CB18-16EA-49AF-B01B-D6993D7950D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3616811-7177-43C0-8120-5CAC96DEFEB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EE5EE69-1404-4C18-8276-65C6C0A4848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F04B7A1-33E3-4B32-A541-2D25188BE78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CC87B26-3E7A-4593-BBA5-85F476D4BC6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69559A7-369A-4DD0-8762-95A86343DAB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98A9F99-B303-4C64-870E-62457F9D8B4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735A987-4DE4-4F1A-BA80-B5D63FA50F4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8C990C7-52A6-4FA9-91D4-3F9F5B496DA9}"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Chart 1" descr=""/>
          <p:cNvPicPr/>
          <p:nvPr/>
        </p:nvPicPr>
        <p:blipFill>
          <a:blip r:embed="rId1"/>
          <a:stretch/>
        </p:blipFill>
        <p:spPr>
          <a:xfrm>
            <a:off x="1590840" y="4791240"/>
            <a:ext cx="3828960" cy="2689200"/>
          </a:xfrm>
          <a:prstGeom prst="rect">
            <a:avLst/>
          </a:prstGeom>
          <a:ln w="0">
            <a:noFill/>
          </a:ln>
        </p:spPr>
      </p:pic>
      <p:pic>
        <p:nvPicPr>
          <p:cNvPr id="42" name="Chart 2" descr=""/>
          <p:cNvPicPr/>
          <p:nvPr/>
        </p:nvPicPr>
        <p:blipFill>
          <a:blip r:embed="rId2"/>
          <a:stretch/>
        </p:blipFill>
        <p:spPr>
          <a:xfrm>
            <a:off x="1590840" y="1816200"/>
            <a:ext cx="3828960" cy="2768400"/>
          </a:xfrm>
          <a:prstGeom prst="rect">
            <a:avLst/>
          </a:prstGeom>
          <a:ln w="0">
            <a:noFill/>
          </a:ln>
        </p:spPr>
      </p:pic>
      <p:sp>
        <p:nvSpPr>
          <p:cNvPr id="43" name="TextBox 4"/>
          <p:cNvSpPr/>
          <p:nvPr/>
        </p:nvSpPr>
        <p:spPr>
          <a:xfrm>
            <a:off x="457200" y="533520"/>
            <a:ext cx="5943600" cy="10065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Additional File 7. </a:t>
            </a:r>
            <a:r>
              <a:rPr b="0" lang="en-US" sz="1200" spc="-1" strike="noStrike">
                <a:solidFill>
                  <a:srgbClr val="000000"/>
                </a:solidFill>
                <a:latin typeface="Times New Roman"/>
                <a:ea typeface="Times New Roman"/>
              </a:rPr>
              <a:t>Quantitative Real Time-PCR analysis in different biological samples of PUSABGD72 and ICCV2 showing normalized fold induction of two ESTs (FL12394 and FL518992) upon drought treatment. The experiment was done in triplicates by taking </a:t>
            </a:r>
            <a:r>
              <a:rPr b="0" i="1" lang="en-US" sz="1200" spc="-1" strike="noStrike">
                <a:solidFill>
                  <a:srgbClr val="000000"/>
                </a:solidFill>
                <a:latin typeface="Times New Roman"/>
                <a:ea typeface="Times New Roman"/>
              </a:rPr>
              <a:t>Actin</a:t>
            </a:r>
            <a:r>
              <a:rPr b="0" lang="en-US" sz="1200" spc="-1" strike="noStrike">
                <a:solidFill>
                  <a:srgbClr val="000000"/>
                </a:solidFill>
                <a:latin typeface="Times New Roman"/>
                <a:ea typeface="Times New Roman"/>
              </a:rPr>
              <a:t> as an internal control.</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6-07T23:52:21Z</dcterms:created>
  <dc:creator>Deepti Jain</dc:creator>
  <dc:description/>
  <dc:language>en-US</dc:language>
  <cp:lastModifiedBy>Deepti</cp:lastModifiedBy>
  <dcterms:modified xsi:type="dcterms:W3CDTF">2010-01-29T15:18:56Z</dcterms:modified>
  <cp:revision>8</cp:revision>
  <dc:subject/>
  <dc:title>Slide 1</dc:title>
</cp:coreProperties>
</file>